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99" d="100"/>
          <a:sy n="99" d="100"/>
        </p:scale>
        <p:origin x="50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ianne Campbell" userId="221e60a4-dfd8-4552-88b6-64bd2a28d228" providerId="ADAL" clId="{42C45EC2-1B3B-4C52-9273-51FE0521E50F}"/>
    <pc:docChg chg="modSld">
      <pc:chgData name="Dianne Campbell" userId="221e60a4-dfd8-4552-88b6-64bd2a28d228" providerId="ADAL" clId="{42C45EC2-1B3B-4C52-9273-51FE0521E50F}" dt="2022-07-07T06:20:08.523" v="8" actId="20577"/>
      <pc:docMkLst>
        <pc:docMk/>
      </pc:docMkLst>
      <pc:sldChg chg="modSp mod">
        <pc:chgData name="Dianne Campbell" userId="221e60a4-dfd8-4552-88b6-64bd2a28d228" providerId="ADAL" clId="{42C45EC2-1B3B-4C52-9273-51FE0521E50F}" dt="2022-07-07T06:20:08.523" v="8" actId="20577"/>
        <pc:sldMkLst>
          <pc:docMk/>
          <pc:sldMk cId="3102601311" sldId="260"/>
        </pc:sldMkLst>
        <pc:spChg chg="mod">
          <ac:chgData name="Dianne Campbell" userId="221e60a4-dfd8-4552-88b6-64bd2a28d228" providerId="ADAL" clId="{42C45EC2-1B3B-4C52-9273-51FE0521E50F}" dt="2022-07-07T06:20:08.523" v="8" actId="20577"/>
          <ac:spMkLst>
            <pc:docMk/>
            <pc:sldMk cId="3102601311" sldId="260"/>
            <ac:spMk id="2" creationId="{6713D085-058C-41D4-8B8C-8EE61A0B0BCA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E7A661-AA47-46F1-9CEC-0D20072DBD8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CD9636D-4B4E-4722-A154-F6B421912E9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A19402-EFC4-4E80-B11E-2FF2DD920C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3E5FA5-82BA-4675-96EF-01BD6DF147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9F2D14-59E3-4F97-A0A7-EE3111D94C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31556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C030C9-467C-4243-A87D-53EB52DCC8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8A1297B-28B4-4B28-BA06-4C99E4EB16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C96439-E4B1-40B0-82E7-AB45D6FE5C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8304A1-215D-452C-92BF-E349EABADB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1A2463-D669-4F87-82D3-9A0EADC233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73395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7F43255-A226-4D3E-B266-1B443C28089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166A868-13D4-4160-9EA3-E208E54F7E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169FB2-8389-4E93-9287-8DF5DE5772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66C2D6-6A4A-41CF-9EAB-52147664A1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FF5020-19B7-4ABD-A426-DF9AD9AD06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5909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CFEE1D-7A02-4DF0-889E-79E454F52D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2C5DB7-0A20-4815-813E-13A7BC9E88F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A20188-9052-4528-8085-181651D7A9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DA622D-C89D-4EEF-953B-15199CB52F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E56D31-5E2E-4CD6-92A2-0F82AA5E57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64921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61C1F0-E0D3-41E8-8C69-349A732781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2D18D9-BCBB-4D4E-90BE-EF6CB93E14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FE2E84-B4D1-4874-9F48-7416C57A22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223461-0D10-4D25-9C82-F1FF78F14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B0A505-F95B-49CF-993D-B99046A425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846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2952F3-DF75-4B1B-95A4-19E0D7397B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9708E1-3CAD-4D57-84ED-A90A29F7970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0FE1999-8389-4426-B7A6-3EE810FBFF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7EE784-4888-45CC-9F21-0993ECB5D4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417D05-69AE-41B3-8E1D-664518467B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7AE7BF6-FC43-4520-A918-267A7800D2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32223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23067E-78A2-45AF-9EA9-0071B61792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9B2BB6F-0082-40FD-A012-9577A55BB6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B471E41-DA37-4847-84B6-81AEFA78F0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B27CC91-D0C4-4028-AF99-D0E86FDB052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8A1C5DD-C790-4734-9FEA-087EFC2F037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EF690AB-E8B4-469F-9E4E-997C3E38E3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57CBAC5-CD9A-4544-B8B1-3316E300AB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A8E03E4-79D8-41AC-9F62-93DC1668A0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3732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D7F7B5-1F31-4170-B48F-5EEAC0B91F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9C73330-51BC-4169-A4A3-E8C3A9820F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A81C04D-A678-4B7A-BB20-C7AA29C0EE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7255271-FABA-4081-88F3-0ED0B77010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78669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0564539-DA8C-4F29-B3C9-BADA85AF7C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3F40545-EFAC-4CD0-96E8-9F84E83012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743A729-5CC0-47E3-A5D8-35CBDF2007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74782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3AE978-A111-419C-BD5B-03C86ED4C6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7DF7A1-BEE7-445B-A34A-6228FBBD099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E6C5B95-D718-4C8A-ACF8-6B66738109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7C59AC-76B2-46E2-B53C-6EBA05A0DC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4F3146-AD69-4F69-A3D5-CFD5A46255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01BDC1E-A3FE-41BA-9C97-F036000F83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0659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1568BF-84AB-44EA-9893-C86C34C4E8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6D928C5-E879-4576-88D8-B9DEF805D96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F432414-199D-46EA-9394-940B3AF8E7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C870B8-C784-4241-A83E-D78D9C5C57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96ED6E-6143-4D2D-93DA-D913208A69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D1A0DDC-FBA1-437C-9F77-F168E7FC79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61609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E918A5F-5A97-4B6D-B687-77C1C0C9CA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A9B010-4A5C-46C6-8B2B-A982F39060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76EBC2-C018-4B40-B328-D9FFFECCDAB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A37E86-B462-49EB-B163-BEF8DEEAEA1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731D1B-D21D-4594-A368-3BA62078C27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46628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713D085-058C-41D4-8B8C-8EE61A0B0BCA}"/>
              </a:ext>
            </a:extLst>
          </p:cNvPr>
          <p:cNvSpPr txBox="1"/>
          <p:nvPr/>
        </p:nvSpPr>
        <p:spPr>
          <a:xfrm>
            <a:off x="0" y="0"/>
            <a:ext cx="25025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E3, REALISE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B80CFB42-C43B-455F-883B-62ECADE251C5}"/>
              </a:ext>
            </a:extLst>
          </p:cNvPr>
          <p:cNvGrpSpPr/>
          <p:nvPr/>
        </p:nvGrpSpPr>
        <p:grpSpPr>
          <a:xfrm>
            <a:off x="2762987" y="568566"/>
            <a:ext cx="6257011" cy="5387617"/>
            <a:chOff x="2762987" y="568566"/>
            <a:chExt cx="6257011" cy="5387617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C8B59D42-D748-4C31-9063-E31AC8AE221F}"/>
                </a:ext>
              </a:extLst>
            </p:cNvPr>
            <p:cNvGrpSpPr/>
            <p:nvPr/>
          </p:nvGrpSpPr>
          <p:grpSpPr>
            <a:xfrm>
              <a:off x="4239928" y="568566"/>
              <a:ext cx="2209559" cy="442872"/>
              <a:chOff x="2875855" y="428096"/>
              <a:chExt cx="2376289" cy="1188144"/>
            </a:xfrm>
            <a:noFill/>
          </p:grpSpPr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8FCEFFA0-43A7-4B8D-9A10-959A91DE071E}"/>
                  </a:ext>
                </a:extLst>
              </p:cNvPr>
              <p:cNvSpPr/>
              <p:nvPr/>
            </p:nvSpPr>
            <p:spPr>
              <a:xfrm>
                <a:off x="2875855" y="428096"/>
                <a:ext cx="2376289" cy="1188144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D4E92D60-3DAE-47A7-88A8-CD7188C41EA5}"/>
                  </a:ext>
                </a:extLst>
              </p:cNvPr>
              <p:cNvSpPr txBox="1"/>
              <p:nvPr/>
            </p:nvSpPr>
            <p:spPr>
              <a:xfrm>
                <a:off x="2875855" y="428096"/>
                <a:ext cx="2376289" cy="1188144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lt1"/>
              </a:fontRef>
            </p:style>
            <p:txBody>
              <a:bodyPr spcFirstLastPara="0" vert="horz" wrap="square" lIns="12700" tIns="12700" rIns="12700" bIns="12700" numCol="1" spcCol="1270" anchor="ctr" anchorCtr="0">
                <a:noAutofit/>
              </a:bodyPr>
              <a:lstStyle/>
              <a:p>
                <a:pPr marL="0" lvl="0" indent="0" algn="ctr" defTabSz="889000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sz="1600" b="1" kern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83 </a:t>
                </a:r>
                <a:r>
                  <a:rPr lang="en-US" sz="1600" kern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creened population</a:t>
                </a:r>
              </a:p>
            </p:txBody>
          </p:sp>
        </p:grp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BEB0D9E-FE65-4884-93CF-E81CF398A571}"/>
                </a:ext>
              </a:extLst>
            </p:cNvPr>
            <p:cNvSpPr txBox="1"/>
            <p:nvPr/>
          </p:nvSpPr>
          <p:spPr>
            <a:xfrm>
              <a:off x="7120528" y="843944"/>
              <a:ext cx="1899470" cy="857719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12700" tIns="12700" rIns="12700" bIns="12700" numCol="1" spcCol="1270" anchor="ctr" anchorCtr="0">
              <a:noAutofit/>
            </a:bodyPr>
            <a:lstStyle/>
            <a:p>
              <a:pPr marL="0" lvl="0" indent="0" algn="ctr" defTabSz="8890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400" b="1" kern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0 excluded </a:t>
              </a:r>
            </a:p>
            <a:p>
              <a:pPr marL="0" lvl="0" indent="0" algn="ctr" defTabSz="8890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200" kern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0 Did not meet inclusion/exclusion criteria</a:t>
              </a:r>
            </a:p>
            <a:p>
              <a:pPr marL="0" lvl="0" indent="0" algn="ctr" defTabSz="8890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 declined to participate</a:t>
              </a:r>
              <a:endParaRPr lang="en-US" sz="1200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F134718B-7A1E-4608-9BC4-CD65109D9632}"/>
                </a:ext>
              </a:extLst>
            </p:cNvPr>
            <p:cNvGrpSpPr/>
            <p:nvPr/>
          </p:nvGrpSpPr>
          <p:grpSpPr>
            <a:xfrm>
              <a:off x="4239939" y="1543245"/>
              <a:ext cx="2209559" cy="442872"/>
              <a:chOff x="1438200" y="2115261"/>
              <a:chExt cx="2376289" cy="1188144"/>
            </a:xfrm>
            <a:noFill/>
          </p:grpSpPr>
          <p:sp>
            <p:nvSpPr>
              <p:cNvPr id="19" name="Rectangle 18">
                <a:extLst>
                  <a:ext uri="{FF2B5EF4-FFF2-40B4-BE49-F238E27FC236}">
                    <a16:creationId xmlns:a16="http://schemas.microsoft.com/office/drawing/2014/main" id="{E2B8F9C2-76F5-40B8-882B-C38D193C645C}"/>
                  </a:ext>
                </a:extLst>
              </p:cNvPr>
              <p:cNvSpPr/>
              <p:nvPr/>
            </p:nvSpPr>
            <p:spPr>
              <a:xfrm>
                <a:off x="1438200" y="2115261"/>
                <a:ext cx="2376289" cy="1188144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B9BD0CCC-8F9D-4A5F-91AF-137F24F41836}"/>
                  </a:ext>
                </a:extLst>
              </p:cNvPr>
              <p:cNvSpPr txBox="1"/>
              <p:nvPr/>
            </p:nvSpPr>
            <p:spPr>
              <a:xfrm>
                <a:off x="1438200" y="2115261"/>
                <a:ext cx="2376289" cy="1188144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lt1"/>
              </a:fontRef>
            </p:style>
            <p:txBody>
              <a:bodyPr spcFirstLastPara="0" vert="horz" wrap="square" lIns="12700" tIns="12700" rIns="12700" bIns="12700" numCol="1" spcCol="1270" anchor="ctr" anchorCtr="0">
                <a:noAutofit/>
              </a:bodyPr>
              <a:lstStyle/>
              <a:p>
                <a:pPr marL="0" lvl="0" indent="0" algn="ctr" defTabSz="889000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sz="1600" b="1" kern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93 </a:t>
                </a:r>
                <a:r>
                  <a:rPr lang="en-US" sz="1600" kern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andomized</a:t>
                </a:r>
              </a:p>
            </p:txBody>
          </p:sp>
        </p:grp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3652127F-E64E-40F5-9545-C0964D5DDC76}"/>
                </a:ext>
              </a:extLst>
            </p:cNvPr>
            <p:cNvGrpSpPr/>
            <p:nvPr/>
          </p:nvGrpSpPr>
          <p:grpSpPr>
            <a:xfrm>
              <a:off x="4239938" y="2515870"/>
              <a:ext cx="2209549" cy="851585"/>
              <a:chOff x="1438200" y="2115261"/>
              <a:chExt cx="2376289" cy="1188144"/>
            </a:xfrm>
            <a:noFill/>
          </p:grpSpPr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6C34D1A3-236F-4094-865F-6736F0E4CE95}"/>
                  </a:ext>
                </a:extLst>
              </p:cNvPr>
              <p:cNvSpPr/>
              <p:nvPr/>
            </p:nvSpPr>
            <p:spPr>
              <a:xfrm>
                <a:off x="1438200" y="2115261"/>
                <a:ext cx="2376289" cy="1188144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39875723-D4D1-4501-B5D5-8D3042169124}"/>
                  </a:ext>
                </a:extLst>
              </p:cNvPr>
              <p:cNvSpPr txBox="1"/>
              <p:nvPr/>
            </p:nvSpPr>
            <p:spPr>
              <a:xfrm>
                <a:off x="1438200" y="2115261"/>
                <a:ext cx="2376289" cy="1188144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lt1"/>
              </a:fontRef>
            </p:style>
            <p:txBody>
              <a:bodyPr spcFirstLastPara="0" vert="horz" wrap="square" lIns="12700" tIns="12700" rIns="12700" bIns="12700" numCol="1" spcCol="1270" anchor="ctr" anchorCtr="0">
                <a:noAutofit/>
              </a:bodyPr>
              <a:lstStyle/>
              <a:p>
                <a:pPr marL="0" lvl="0" indent="0" algn="ctr" defTabSz="889000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sz="1600" b="1" kern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93 </a:t>
                </a:r>
                <a:r>
                  <a:rPr lang="en-US" sz="1600" kern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ceived </a:t>
                </a:r>
                <a:br>
                  <a:rPr lang="en-US" sz="1600" kern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</a:br>
                <a:r>
                  <a:rPr lang="en-US" sz="1600" kern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ouble-blind treatment </a:t>
                </a:r>
              </a:p>
              <a:p>
                <a:pPr marL="0" lvl="0" indent="0" algn="ctr" defTabSz="889000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sz="1600" kern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safety population)</a:t>
                </a:r>
              </a:p>
            </p:txBody>
          </p:sp>
        </p:grpSp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ECD64947-3CAE-4501-B47A-4C91E74FEB14}"/>
                </a:ext>
              </a:extLst>
            </p:cNvPr>
            <p:cNvGrpSpPr/>
            <p:nvPr/>
          </p:nvGrpSpPr>
          <p:grpSpPr>
            <a:xfrm>
              <a:off x="2762989" y="3894797"/>
              <a:ext cx="2209559" cy="442872"/>
              <a:chOff x="1438200" y="2115261"/>
              <a:chExt cx="2376289" cy="1188144"/>
            </a:xfrm>
            <a:noFill/>
          </p:grpSpPr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62CEEB80-84C8-4017-8F96-659D09231939}"/>
                  </a:ext>
                </a:extLst>
              </p:cNvPr>
              <p:cNvSpPr/>
              <p:nvPr/>
            </p:nvSpPr>
            <p:spPr>
              <a:xfrm>
                <a:off x="1438200" y="2115261"/>
                <a:ext cx="2376289" cy="1188144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317FE7B4-2D37-4A1F-9901-3FF5C5C7ABCE}"/>
                  </a:ext>
                </a:extLst>
              </p:cNvPr>
              <p:cNvSpPr txBox="1"/>
              <p:nvPr/>
            </p:nvSpPr>
            <p:spPr>
              <a:xfrm>
                <a:off x="1438200" y="2115261"/>
                <a:ext cx="2376289" cy="1188144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lt1"/>
              </a:fontRef>
            </p:style>
            <p:txBody>
              <a:bodyPr spcFirstLastPara="0" vert="horz" wrap="square" lIns="12700" tIns="12700" rIns="12700" bIns="12700" numCol="1" spcCol="1270" anchor="ctr" anchorCtr="0">
                <a:noAutofit/>
              </a:bodyPr>
              <a:lstStyle/>
              <a:p>
                <a:pPr marL="0" lvl="0" indent="0" algn="ctr" defTabSz="889000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sz="1600" b="1" kern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9 </a:t>
                </a:r>
                <a:r>
                  <a:rPr lang="en-US" sz="1600" kern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ceived placebo</a:t>
                </a:r>
              </a:p>
            </p:txBody>
          </p:sp>
        </p:grp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4D94A491-38CE-4DC6-9313-242383370D80}"/>
                </a:ext>
              </a:extLst>
            </p:cNvPr>
            <p:cNvGrpSpPr/>
            <p:nvPr/>
          </p:nvGrpSpPr>
          <p:grpSpPr>
            <a:xfrm>
              <a:off x="5743712" y="3899263"/>
              <a:ext cx="2209525" cy="438406"/>
              <a:chOff x="1438200" y="2115261"/>
              <a:chExt cx="2376289" cy="1188144"/>
            </a:xfrm>
            <a:noFill/>
          </p:grpSpPr>
          <p:sp>
            <p:nvSpPr>
              <p:cNvPr id="29" name="Rectangle 28">
                <a:extLst>
                  <a:ext uri="{FF2B5EF4-FFF2-40B4-BE49-F238E27FC236}">
                    <a16:creationId xmlns:a16="http://schemas.microsoft.com/office/drawing/2014/main" id="{485A1646-50AA-482E-B6AB-FCD488C98E61}"/>
                  </a:ext>
                </a:extLst>
              </p:cNvPr>
              <p:cNvSpPr/>
              <p:nvPr/>
            </p:nvSpPr>
            <p:spPr>
              <a:xfrm>
                <a:off x="1438200" y="2115261"/>
                <a:ext cx="2376289" cy="1188144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BB751197-DE44-47D3-8CB8-D84203913A42}"/>
                  </a:ext>
                </a:extLst>
              </p:cNvPr>
              <p:cNvSpPr txBox="1"/>
              <p:nvPr/>
            </p:nvSpPr>
            <p:spPr>
              <a:xfrm>
                <a:off x="1438200" y="2115261"/>
                <a:ext cx="2376289" cy="1188144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lt1"/>
              </a:fontRef>
            </p:style>
            <p:txBody>
              <a:bodyPr spcFirstLastPara="0" vert="horz" wrap="square" lIns="12700" tIns="12700" rIns="12700" bIns="12700" numCol="1" spcCol="1270" anchor="ctr" anchorCtr="0">
                <a:noAutofit/>
              </a:bodyPr>
              <a:lstStyle/>
              <a:p>
                <a:pPr marL="0" lvl="0" indent="0" algn="ctr" defTabSz="889000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sz="1600" b="1" kern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94 </a:t>
                </a:r>
                <a:r>
                  <a:rPr lang="en-US" sz="1600" kern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ceived </a:t>
                </a:r>
                <a:br>
                  <a:rPr lang="en-US" sz="1600" kern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</a:br>
                <a:r>
                  <a:rPr lang="en-US" sz="16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iaskin</a:t>
                </a:r>
                <a:r>
                  <a:rPr lang="en-US" sz="1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eanut 250 µg</a:t>
                </a:r>
                <a:endParaRPr lang="en-US" sz="1600" kern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9B6664E0-5556-4D6D-A27F-0BD487DC6EFF}"/>
                </a:ext>
              </a:extLst>
            </p:cNvPr>
            <p:cNvGrpSpPr/>
            <p:nvPr/>
          </p:nvGrpSpPr>
          <p:grpSpPr>
            <a:xfrm>
              <a:off x="2762987" y="5235443"/>
              <a:ext cx="2209555" cy="720740"/>
              <a:chOff x="1438200" y="2115261"/>
              <a:chExt cx="2376289" cy="1188144"/>
            </a:xfrm>
            <a:noFill/>
          </p:grpSpPr>
          <p:sp>
            <p:nvSpPr>
              <p:cNvPr id="32" name="Rectangle 31">
                <a:extLst>
                  <a:ext uri="{FF2B5EF4-FFF2-40B4-BE49-F238E27FC236}">
                    <a16:creationId xmlns:a16="http://schemas.microsoft.com/office/drawing/2014/main" id="{62C2FA60-A6D2-4F41-93B7-BDF3D51890C0}"/>
                  </a:ext>
                </a:extLst>
              </p:cNvPr>
              <p:cNvSpPr/>
              <p:nvPr/>
            </p:nvSpPr>
            <p:spPr>
              <a:xfrm>
                <a:off x="1438200" y="2115261"/>
                <a:ext cx="2376289" cy="1188144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ADCFD1E9-30C9-4BA5-BB99-D1DA95CDBF6C}"/>
                  </a:ext>
                </a:extLst>
              </p:cNvPr>
              <p:cNvSpPr txBox="1"/>
              <p:nvPr/>
            </p:nvSpPr>
            <p:spPr>
              <a:xfrm>
                <a:off x="1438200" y="2115261"/>
                <a:ext cx="2376288" cy="1188144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lt1"/>
              </a:fontRef>
            </p:style>
            <p:txBody>
              <a:bodyPr spcFirstLastPara="0" vert="horz" wrap="square" lIns="12700" tIns="12700" rIns="12700" bIns="12700" numCol="1" spcCol="1270" anchor="ctr" anchorCtr="0">
                <a:noAutofit/>
              </a:bodyPr>
              <a:lstStyle/>
              <a:p>
                <a:pPr marL="0" lvl="0" indent="0" algn="ctr" defTabSz="889000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sz="1600" b="1" kern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8 (99.0%) </a:t>
                </a:r>
                <a:r>
                  <a:rPr lang="en-US" sz="1600" kern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mpleted double-blind treatment</a:t>
                </a:r>
              </a:p>
            </p:txBody>
          </p:sp>
        </p:grp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46124849-2614-4EE3-9A4E-E3FD5CACB428}"/>
                </a:ext>
              </a:extLst>
            </p:cNvPr>
            <p:cNvGrpSpPr/>
            <p:nvPr/>
          </p:nvGrpSpPr>
          <p:grpSpPr>
            <a:xfrm>
              <a:off x="5743675" y="5235443"/>
              <a:ext cx="2209555" cy="720740"/>
              <a:chOff x="1438200" y="2115261"/>
              <a:chExt cx="2376289" cy="1188144"/>
            </a:xfrm>
            <a:noFill/>
          </p:grpSpPr>
          <p:sp>
            <p:nvSpPr>
              <p:cNvPr id="35" name="Rectangle 34">
                <a:extLst>
                  <a:ext uri="{FF2B5EF4-FFF2-40B4-BE49-F238E27FC236}">
                    <a16:creationId xmlns:a16="http://schemas.microsoft.com/office/drawing/2014/main" id="{46115AFD-7624-4503-A574-28FE668D0C80}"/>
                  </a:ext>
                </a:extLst>
              </p:cNvPr>
              <p:cNvSpPr/>
              <p:nvPr/>
            </p:nvSpPr>
            <p:spPr>
              <a:xfrm>
                <a:off x="1438200" y="2115261"/>
                <a:ext cx="2376289" cy="1188144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73F98731-6FB4-4640-B710-566EA1134C0D}"/>
                  </a:ext>
                </a:extLst>
              </p:cNvPr>
              <p:cNvSpPr txBox="1"/>
              <p:nvPr/>
            </p:nvSpPr>
            <p:spPr>
              <a:xfrm>
                <a:off x="1438200" y="2115261"/>
                <a:ext cx="2376289" cy="1188144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lt1"/>
              </a:fontRef>
            </p:style>
            <p:txBody>
              <a:bodyPr spcFirstLastPara="0" vert="horz" wrap="square" lIns="12700" tIns="12700" rIns="12700" bIns="12700" numCol="1" spcCol="1270" anchor="ctr" anchorCtr="0">
                <a:noAutofit/>
              </a:bodyPr>
              <a:lstStyle/>
              <a:p>
                <a:pPr marL="0" lvl="0" indent="0" algn="ctr" defTabSz="889000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sz="1600" b="1" kern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85 (96.9%) </a:t>
                </a:r>
                <a:r>
                  <a:rPr lang="en-US" sz="1600" kern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mpleted double-blind treatment</a:t>
                </a:r>
              </a:p>
            </p:txBody>
          </p:sp>
        </p:grpSp>
        <p:grpSp>
          <p:nvGrpSpPr>
            <p:cNvPr id="39" name="Group 38">
              <a:extLst>
                <a:ext uri="{FF2B5EF4-FFF2-40B4-BE49-F238E27FC236}">
                  <a16:creationId xmlns:a16="http://schemas.microsoft.com/office/drawing/2014/main" id="{13953C09-88B7-4EC3-A5E2-3C41FB077E75}"/>
                </a:ext>
              </a:extLst>
            </p:cNvPr>
            <p:cNvGrpSpPr/>
            <p:nvPr/>
          </p:nvGrpSpPr>
          <p:grpSpPr>
            <a:xfrm>
              <a:off x="2762988" y="4566933"/>
              <a:ext cx="2209555" cy="442873"/>
              <a:chOff x="1438200" y="2115261"/>
              <a:chExt cx="2376289" cy="1188144"/>
            </a:xfrm>
            <a:noFill/>
          </p:grpSpPr>
          <p:sp>
            <p:nvSpPr>
              <p:cNvPr id="40" name="Rectangle 39">
                <a:extLst>
                  <a:ext uri="{FF2B5EF4-FFF2-40B4-BE49-F238E27FC236}">
                    <a16:creationId xmlns:a16="http://schemas.microsoft.com/office/drawing/2014/main" id="{433DF850-FBDF-48AB-AB84-0FE6C61E9A56}"/>
                  </a:ext>
                </a:extLst>
              </p:cNvPr>
              <p:cNvSpPr/>
              <p:nvPr/>
            </p:nvSpPr>
            <p:spPr>
              <a:xfrm>
                <a:off x="1438200" y="2115261"/>
                <a:ext cx="2376289" cy="1188144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E773E3E5-B8E1-402A-BD7C-65644AD9CA54}"/>
                  </a:ext>
                </a:extLst>
              </p:cNvPr>
              <p:cNvSpPr txBox="1"/>
              <p:nvPr/>
            </p:nvSpPr>
            <p:spPr>
              <a:xfrm>
                <a:off x="1438200" y="2115261"/>
                <a:ext cx="2376289" cy="1188144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lt1"/>
              </a:fontRef>
            </p:style>
            <p:txBody>
              <a:bodyPr spcFirstLastPara="0" vert="horz" wrap="square" lIns="12700" tIns="12700" rIns="12700" bIns="12700" numCol="1" spcCol="1270" anchor="ctr" anchorCtr="0">
                <a:noAutofit/>
              </a:bodyPr>
              <a:lstStyle/>
              <a:p>
                <a:pPr marL="0" lvl="0" indent="0" algn="ctr" defTabSz="889000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sz="1600" b="1" kern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 (1.0%) </a:t>
                </a:r>
                <a:r>
                  <a:rPr lang="en-US" sz="1600" kern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iscontinued</a:t>
                </a:r>
              </a:p>
            </p:txBody>
          </p:sp>
        </p:grpSp>
        <p:grpSp>
          <p:nvGrpSpPr>
            <p:cNvPr id="42" name="Group 41">
              <a:extLst>
                <a:ext uri="{FF2B5EF4-FFF2-40B4-BE49-F238E27FC236}">
                  <a16:creationId xmlns:a16="http://schemas.microsoft.com/office/drawing/2014/main" id="{D7F3C04B-8098-4CEF-BA99-AB68015DBC9C}"/>
                </a:ext>
              </a:extLst>
            </p:cNvPr>
            <p:cNvGrpSpPr/>
            <p:nvPr/>
          </p:nvGrpSpPr>
          <p:grpSpPr>
            <a:xfrm>
              <a:off x="5743711" y="4566933"/>
              <a:ext cx="2209519" cy="438407"/>
              <a:chOff x="1438200" y="2115261"/>
              <a:chExt cx="2376289" cy="1188144"/>
            </a:xfrm>
            <a:noFill/>
          </p:grpSpPr>
          <p:sp>
            <p:nvSpPr>
              <p:cNvPr id="43" name="Rectangle 42">
                <a:extLst>
                  <a:ext uri="{FF2B5EF4-FFF2-40B4-BE49-F238E27FC236}">
                    <a16:creationId xmlns:a16="http://schemas.microsoft.com/office/drawing/2014/main" id="{167BB57E-2E86-4EAB-B8D6-A61090988BEF}"/>
                  </a:ext>
                </a:extLst>
              </p:cNvPr>
              <p:cNvSpPr/>
              <p:nvPr/>
            </p:nvSpPr>
            <p:spPr>
              <a:xfrm>
                <a:off x="1438200" y="2115261"/>
                <a:ext cx="2376289" cy="1188144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2F2988F2-CB7F-4BFD-938B-4132C457D3AA}"/>
                  </a:ext>
                </a:extLst>
              </p:cNvPr>
              <p:cNvSpPr txBox="1"/>
              <p:nvPr/>
            </p:nvSpPr>
            <p:spPr>
              <a:xfrm>
                <a:off x="1438200" y="2115261"/>
                <a:ext cx="2376289" cy="1188144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lt1"/>
              </a:fontRef>
            </p:style>
            <p:txBody>
              <a:bodyPr spcFirstLastPara="0" vert="horz" wrap="square" lIns="12700" tIns="12700" rIns="12700" bIns="12700" numCol="1" spcCol="1270" anchor="ctr" anchorCtr="0">
                <a:noAutofit/>
              </a:bodyPr>
              <a:lstStyle/>
              <a:p>
                <a:pPr marL="0" lvl="0" indent="0" algn="ctr" defTabSz="889000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sz="1600" b="1" kern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 (3.1%) </a:t>
                </a:r>
                <a:r>
                  <a:rPr lang="en-US" sz="1600" kern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iscontinued</a:t>
                </a:r>
              </a:p>
            </p:txBody>
          </p:sp>
        </p:grp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01C9E456-3783-48F2-8B91-AC3A49DDF5D4}"/>
                </a:ext>
              </a:extLst>
            </p:cNvPr>
            <p:cNvCxnSpPr>
              <a:stCxn id="8" idx="2"/>
              <a:endCxn id="20" idx="0"/>
            </p:cNvCxnSpPr>
            <p:nvPr/>
          </p:nvCxnSpPr>
          <p:spPr>
            <a:xfrm>
              <a:off x="5344708" y="1011438"/>
              <a:ext cx="11" cy="53180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id="{8258551C-07D0-4BB0-A9D7-7BA4B93BFB24}"/>
                </a:ext>
              </a:extLst>
            </p:cNvPr>
            <p:cNvCxnSpPr>
              <a:cxnSpLocks/>
              <a:stCxn id="20" idx="2"/>
              <a:endCxn id="24" idx="0"/>
            </p:cNvCxnSpPr>
            <p:nvPr/>
          </p:nvCxnSpPr>
          <p:spPr>
            <a:xfrm flipH="1">
              <a:off x="5344713" y="1986117"/>
              <a:ext cx="6" cy="52975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6C8E7F90-3700-4F76-86D7-7A8A9B52417E}"/>
                </a:ext>
              </a:extLst>
            </p:cNvPr>
            <p:cNvCxnSpPr>
              <a:cxnSpLocks/>
              <a:endCxn id="7" idx="1"/>
            </p:cNvCxnSpPr>
            <p:nvPr/>
          </p:nvCxnSpPr>
          <p:spPr>
            <a:xfrm>
              <a:off x="5344719" y="1272804"/>
              <a:ext cx="177580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72" name="Straight Connector 71">
              <a:extLst>
                <a:ext uri="{FF2B5EF4-FFF2-40B4-BE49-F238E27FC236}">
                  <a16:creationId xmlns:a16="http://schemas.microsoft.com/office/drawing/2014/main" id="{D6284B77-4F6A-4645-8872-87C7010D5608}"/>
                </a:ext>
              </a:extLst>
            </p:cNvPr>
            <p:cNvCxnSpPr>
              <a:cxnSpLocks/>
              <a:stCxn id="27" idx="2"/>
              <a:endCxn id="41" idx="0"/>
            </p:cNvCxnSpPr>
            <p:nvPr/>
          </p:nvCxnSpPr>
          <p:spPr>
            <a:xfrm flipH="1">
              <a:off x="3867766" y="4337669"/>
              <a:ext cx="3" cy="22926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73" name="Straight Connector 72">
              <a:extLst>
                <a:ext uri="{FF2B5EF4-FFF2-40B4-BE49-F238E27FC236}">
                  <a16:creationId xmlns:a16="http://schemas.microsoft.com/office/drawing/2014/main" id="{BF41D7F8-F751-423E-99AF-3AC156BB98CB}"/>
                </a:ext>
              </a:extLst>
            </p:cNvPr>
            <p:cNvCxnSpPr>
              <a:cxnSpLocks/>
              <a:stCxn id="30" idx="2"/>
              <a:endCxn id="44" idx="0"/>
            </p:cNvCxnSpPr>
            <p:nvPr/>
          </p:nvCxnSpPr>
          <p:spPr>
            <a:xfrm flipH="1">
              <a:off x="6848471" y="4337669"/>
              <a:ext cx="4" cy="22926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Connector: Elbow 11">
              <a:extLst>
                <a:ext uri="{FF2B5EF4-FFF2-40B4-BE49-F238E27FC236}">
                  <a16:creationId xmlns:a16="http://schemas.microsoft.com/office/drawing/2014/main" id="{CABB32B2-65E7-46AC-87BF-453BAFBDC770}"/>
                </a:ext>
              </a:extLst>
            </p:cNvPr>
            <p:cNvCxnSpPr>
              <a:stCxn id="24" idx="2"/>
              <a:endCxn id="27" idx="0"/>
            </p:cNvCxnSpPr>
            <p:nvPr/>
          </p:nvCxnSpPr>
          <p:spPr>
            <a:xfrm rot="5400000">
              <a:off x="4342570" y="2892654"/>
              <a:ext cx="527342" cy="1476944"/>
            </a:xfrm>
            <a:prstGeom prst="bentConnector3">
              <a:avLst/>
            </a:prstGeom>
            <a:ln>
              <a:solidFill>
                <a:schemeClr val="tx1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7" name="Connector: Elbow 46">
              <a:extLst>
                <a:ext uri="{FF2B5EF4-FFF2-40B4-BE49-F238E27FC236}">
                  <a16:creationId xmlns:a16="http://schemas.microsoft.com/office/drawing/2014/main" id="{BC8D0C01-568E-4FF8-B111-62DD77513489}"/>
                </a:ext>
              </a:extLst>
            </p:cNvPr>
            <p:cNvCxnSpPr>
              <a:cxnSpLocks/>
              <a:stCxn id="24" idx="2"/>
              <a:endCxn id="29" idx="0"/>
            </p:cNvCxnSpPr>
            <p:nvPr/>
          </p:nvCxnSpPr>
          <p:spPr>
            <a:xfrm rot="16200000" flipH="1">
              <a:off x="5830690" y="2881478"/>
              <a:ext cx="531808" cy="1503762"/>
            </a:xfrm>
            <a:prstGeom prst="bentConnector3">
              <a:avLst>
                <a:gd name="adj1" fmla="val 50000"/>
              </a:avLst>
            </a:prstGeom>
            <a:ln>
              <a:solidFill>
                <a:schemeClr val="tx1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57" name="Straight Connector 56">
              <a:extLst>
                <a:ext uri="{FF2B5EF4-FFF2-40B4-BE49-F238E27FC236}">
                  <a16:creationId xmlns:a16="http://schemas.microsoft.com/office/drawing/2014/main" id="{FE89EAD0-332F-4E64-9B9B-839BDBE34D7C}"/>
                </a:ext>
              </a:extLst>
            </p:cNvPr>
            <p:cNvCxnSpPr>
              <a:cxnSpLocks/>
              <a:stCxn id="40" idx="2"/>
              <a:endCxn id="33" idx="0"/>
            </p:cNvCxnSpPr>
            <p:nvPr/>
          </p:nvCxnSpPr>
          <p:spPr>
            <a:xfrm flipH="1">
              <a:off x="3867764" y="5009806"/>
              <a:ext cx="2" cy="22563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id="{D0136EFF-C36F-48DE-AA48-6985C7D2D724}"/>
                </a:ext>
              </a:extLst>
            </p:cNvPr>
            <p:cNvCxnSpPr>
              <a:cxnSpLocks/>
              <a:stCxn id="44" idx="2"/>
              <a:endCxn id="36" idx="0"/>
            </p:cNvCxnSpPr>
            <p:nvPr/>
          </p:nvCxnSpPr>
          <p:spPr>
            <a:xfrm flipH="1">
              <a:off x="6848453" y="5005340"/>
              <a:ext cx="18" cy="23010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1026013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0910E230E33434A8F72B935337CA89F" ma:contentTypeVersion="12" ma:contentTypeDescription="Create a new document." ma:contentTypeScope="" ma:versionID="b3ff08a6f125daa8ebdd740d7b02ce8d">
  <xsd:schema xmlns:xsd="http://www.w3.org/2001/XMLSchema" xmlns:xs="http://www.w3.org/2001/XMLSchema" xmlns:p="http://schemas.microsoft.com/office/2006/metadata/properties" xmlns:ns2="95734648-81ed-4cb3-86b2-a255be970428" xmlns:ns3="e2ccda8d-dc0e-4ba9-a702-5fb58a589676" targetNamespace="http://schemas.microsoft.com/office/2006/metadata/properties" ma:root="true" ma:fieldsID="a265fdcba77d5f8ff2fc6162e3c01732" ns2:_="" ns3:_="">
    <xsd:import namespace="95734648-81ed-4cb3-86b2-a255be970428"/>
    <xsd:import namespace="e2ccda8d-dc0e-4ba9-a702-5fb58a589676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EventHashCode" minOccurs="0"/>
                <xsd:element ref="ns2:MediaServiceGenerationTime" minOccurs="0"/>
                <xsd:element ref="ns2:MediaServiceAutoTags" minOccurs="0"/>
                <xsd:element ref="ns2:MediaServiceOCR" minOccurs="0"/>
                <xsd:element ref="ns2:MediaServiceAutoKeyPoints" minOccurs="0"/>
                <xsd:element ref="ns2:MediaServiceKeyPoints" minOccurs="0"/>
                <xsd:element ref="ns2:MediaServiceDateTaken" minOccurs="0"/>
                <xsd:element ref="ns2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5734648-81ed-4cb3-86b2-a255be970428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EventHashCode" ma:index="12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Tags" ma:index="14" nillable="true" ma:displayName="MediaServiceAutoTags" ma:internalName="MediaServiceAutoTags" ma:readOnly="true">
      <xsd:simpleType>
        <xsd:restriction base="dms:Text"/>
      </xsd:simpleType>
    </xsd:element>
    <xsd:element name="MediaServiceOCR" ma:index="15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2ccda8d-dc0e-4ba9-a702-5fb58a589676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EF64C1B8-775C-48F7-8B34-677F4762532C}">
  <ds:schemaRefs>
    <ds:schemaRef ds:uri="http://purl.org/dc/dcmitype/"/>
    <ds:schemaRef ds:uri="http://purl.org/dc/elements/1.1/"/>
    <ds:schemaRef ds:uri="http://schemas.microsoft.com/office/2006/metadata/properties"/>
    <ds:schemaRef ds:uri="http://schemas.microsoft.com/office/2006/documentManagement/types"/>
    <ds:schemaRef ds:uri="http://purl.org/dc/terms/"/>
    <ds:schemaRef ds:uri="http://www.w3.org/XML/1998/namespace"/>
    <ds:schemaRef ds:uri="http://schemas.microsoft.com/office/infopath/2007/PartnerControls"/>
    <ds:schemaRef ds:uri="http://schemas.openxmlformats.org/package/2006/metadata/core-properties"/>
    <ds:schemaRef ds:uri="1b8c0a43-fee0-4e1c-bf87-ca768e4d5fff"/>
    <ds:schemaRef ds:uri="a70e900c-8360-41e2-bb31-4c3e814607f3"/>
  </ds:schemaRefs>
</ds:datastoreItem>
</file>

<file path=customXml/itemProps2.xml><?xml version="1.0" encoding="utf-8"?>
<ds:datastoreItem xmlns:ds="http://schemas.openxmlformats.org/officeDocument/2006/customXml" ds:itemID="{4AA79E53-8777-4502-99DF-CF71D422ABDA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29F02E3B-DAE4-444A-8B3A-59DF9DD28FE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5734648-81ed-4cb3-86b2-a255be970428"/>
    <ds:schemaRef ds:uri="e2ccda8d-dc0e-4ba9-a702-5fb58a58967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6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morbidities Manuscript Figures</dc:title>
  <dc:creator>Paula Davis</dc:creator>
  <cp:lastModifiedBy>Dianne Campbell</cp:lastModifiedBy>
  <cp:revision>22</cp:revision>
  <dcterms:created xsi:type="dcterms:W3CDTF">2020-10-15T21:56:15Z</dcterms:created>
  <dcterms:modified xsi:type="dcterms:W3CDTF">2022-07-07T06:20:1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0910E230E33434A8F72B935337CA89F</vt:lpwstr>
  </property>
</Properties>
</file>